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14" autoAdjust="0"/>
  </p:normalViewPr>
  <p:slideViewPr>
    <p:cSldViewPr>
      <p:cViewPr varScale="1">
        <p:scale>
          <a:sx n="86" d="100"/>
          <a:sy n="86" d="100"/>
        </p:scale>
        <p:origin x="1746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13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18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57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6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3936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666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885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62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35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78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11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48A9F-E181-486C-8142-30E87DC6A4B4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D0950-B2F2-46D6-9F1B-E3CBB4943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506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9600" y="6400800"/>
            <a:ext cx="559800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1 Table: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aqMan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gene expression 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hermoFisher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 assay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al-tim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uantitative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CR predesign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says used to measure mRNA expressio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7515402"/>
              </p:ext>
            </p:extLst>
          </p:nvPr>
        </p:nvGraphicFramePr>
        <p:xfrm>
          <a:off x="685800" y="2743200"/>
          <a:ext cx="4272637" cy="3408366"/>
        </p:xfrm>
        <a:graphic>
          <a:graphicData uri="http://schemas.openxmlformats.org/drawingml/2006/table">
            <a:tbl>
              <a:tblPr firstRow="1" firstCol="1" bandRow="1"/>
              <a:tblGrid>
                <a:gridCol w="658495">
                  <a:extLst>
                    <a:ext uri="{9D8B030D-6E8A-4147-A177-3AD203B41FA5}">
                      <a16:colId xmlns:a16="http://schemas.microsoft.com/office/drawing/2014/main" val="259310583"/>
                    </a:ext>
                  </a:extLst>
                </a:gridCol>
                <a:gridCol w="1378585">
                  <a:extLst>
                    <a:ext uri="{9D8B030D-6E8A-4147-A177-3AD203B41FA5}">
                      <a16:colId xmlns:a16="http://schemas.microsoft.com/office/drawing/2014/main" val="3393722114"/>
                    </a:ext>
                  </a:extLst>
                </a:gridCol>
                <a:gridCol w="239117">
                  <a:extLst>
                    <a:ext uri="{9D8B030D-6E8A-4147-A177-3AD203B41FA5}">
                      <a16:colId xmlns:a16="http://schemas.microsoft.com/office/drawing/2014/main" val="2585152118"/>
                    </a:ext>
                  </a:extLst>
                </a:gridCol>
                <a:gridCol w="681990">
                  <a:extLst>
                    <a:ext uri="{9D8B030D-6E8A-4147-A177-3AD203B41FA5}">
                      <a16:colId xmlns:a16="http://schemas.microsoft.com/office/drawing/2014/main" val="1274246846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38270044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 Symb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ssay I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e Symb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ssay I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36613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npp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516572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-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45259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52383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-gamm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99999071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rebf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1306292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21136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CP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41242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gcs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550050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36878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466725" algn="l"/>
                        </a:tabLs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1h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37265_g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gat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515643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03867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466725" algn="l"/>
                        </a:tabLs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1135198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bca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42646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43648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yp8b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501637_s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p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34770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14727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pin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550511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NF-alph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99999068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05648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12b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34174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PAR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69562_m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83732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PAR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39145_m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PAR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2620784_s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59717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PAR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69694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PAR-delt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803184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72992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PAR-alph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40939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46190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33479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PAR-gamm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40945_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55562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5749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76</Words>
  <Application>Microsoft Office PowerPoint</Application>
  <PresentationFormat>Letter Paper (8.5x11 in)</PresentationFormat>
  <Paragraphs>6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yth, Susan</dc:creator>
  <cp:lastModifiedBy>McMullen, Colleen</cp:lastModifiedBy>
  <cp:revision>16</cp:revision>
  <cp:lastPrinted>2018-10-21T18:40:01Z</cp:lastPrinted>
  <dcterms:created xsi:type="dcterms:W3CDTF">2018-10-08T19:40:09Z</dcterms:created>
  <dcterms:modified xsi:type="dcterms:W3CDTF">2018-11-15T21:15:47Z</dcterms:modified>
</cp:coreProperties>
</file>